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6" r:id="rId2"/>
    <p:sldId id="261" r:id="rId3"/>
    <p:sldId id="257" r:id="rId4"/>
    <p:sldId id="259" r:id="rId5"/>
    <p:sldId id="265" r:id="rId6"/>
    <p:sldId id="262" r:id="rId7"/>
    <p:sldId id="263" r:id="rId8"/>
  </p:sldIdLst>
  <p:sldSz cx="12192000" cy="6858000"/>
  <p:notesSz cx="6858000" cy="9144000"/>
  <p:defaultTextStyle>
    <a:defPPr>
      <a:defRPr lang="en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47"/>
    <p:restoredTop sz="97030"/>
  </p:normalViewPr>
  <p:slideViewPr>
    <p:cSldViewPr snapToGrid="0">
      <p:cViewPr varScale="1">
        <p:scale>
          <a:sx n="128" d="100"/>
          <a:sy n="128" d="100"/>
        </p:scale>
        <p:origin x="37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390C86-BF1A-814E-8395-6686B546703C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5040E8B-2215-FF49-9436-3CB73B94BA40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2967511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0262DEA-71E7-8B4E-B84F-09E523560359}" type="slidenum">
              <a:rPr lang="en-CN" smtClean="0"/>
              <a:t>3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4238429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956CE60-D7F4-C180-F0BD-74E1466C51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A9F3DA-650F-9391-55AC-D7835BC073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868D9-BF9E-D0D4-F093-9DEE3E929E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51F67B-567D-05EA-0114-A58FFA03C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5DD5F-971A-12C8-5B05-1339E2E16C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404310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9DD8C0-E89D-71C4-3569-1339BE0427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1958BA-341B-B0CC-BCA5-E010C02CC1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AE9143-216C-B8AB-F79C-9B1FDF6479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4F5E08-71EB-C359-D93F-A0B7A826B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EAD0C4-DB28-0B56-E737-9221CB8A1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101524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95CCB41-B745-4B5A-76C2-0B89C9E13BA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649C326-DAB9-FC6C-AEDB-8D33F9F554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94D9E4-A4A2-36D3-60C7-0CA9C4D4F0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E41938-3809-B3C3-0B14-6057A8C741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8B5A7E-3E9A-0509-6192-C2079EAA57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003970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14DF2E-6BF8-E55E-2557-413E1D1927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F8E418-CAB5-7023-326F-831BD3D58F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0F96FF-895D-AADF-89B9-6ACD12EB8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85A922-0A1B-9541-6B94-0634BCE8BC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F1BEC8-5D1A-9155-4F67-0BA76CC40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04628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78AC6D-D16D-A0E5-C2C2-052DBB6B1A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538D7C8-6794-ECEE-95E3-FB09C4E1D0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7E3036-0B35-B1B6-EBCD-595A861861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A1BCD5-533B-EE6C-8B45-6FA5AC7C2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7C8D86-E895-4CB5-1CFC-F84EDAA08D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964191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D5F399-5B73-E1A5-5B2A-79A156CF47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BAF39F-FA36-3114-F18F-6F1867315A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558AE3F-F83A-F382-40EB-74116CB3FB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602192-367D-2DE3-E11B-A3904FB63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6F5F8F-CA5C-497B-311D-A8A9FFBEEE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2C9A50-C2B9-2E4B-0C2A-F657B47AC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1502843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8B9F11-F515-7158-5C77-B1ABE12CCE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16A710-A7E8-BB35-34AE-3F61BEA118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492405-64B0-841C-60C2-188647736E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C7293D1-D800-6B93-30C5-514DAFC81D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E20B0A0-D57B-FAB6-714C-2E069A08EF9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2B58DC-5FDC-D696-0337-B908F9C850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A63E6A0-FFED-CEC3-89B2-706FD322D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AA10FE7-DBD8-2237-383E-7C04A1A6D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1882743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E85FC-5952-0276-FFB3-791FC5C0FE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266F8B-CF3D-21C8-CB66-DE5E242FE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3F14A8-932B-6D8C-7298-620ABCEC3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1DEFDB-360E-68F3-4075-F1BF78665A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041289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ABAAEB-0EEF-3DA0-6150-6526D0CE4B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D5CBF64-43F7-79B3-10A9-7B03F80CF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010B0E-75E3-13BA-5010-BA4670ED7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8924158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BC816B-32C6-831A-03AC-27D24B3E5F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950B98-7793-F0E7-DD0B-BDC19C5548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544A09-F08F-E3F6-3B3C-16CBA35E83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B9F18E-450F-C06B-F199-5CE34D183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E377EC5-05CD-8E92-AD79-06781C366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3638DD5-5A69-8396-C1AD-3F8B6B0DA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302732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D75178-AF3C-C8D4-A9EA-394E5BE1E8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80438C1-5E73-629D-6D22-ECFA298344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B13BD1-AAC3-2121-5E05-2031B7409A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5F8CF5-45BA-E5B5-5726-95A820ECFB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0CCB60-D18C-43B2-50C7-AB75C2F2D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345FC6-8E22-1809-0EF6-BD039690A1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957822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8026379-807B-E2DC-46B4-A85C265DC7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F5B36A-C9BA-DDB0-E49E-A51B5D39FC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4716A4-1BDF-AD37-173E-6810B92B32A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B7588B-D13B-094F-AC59-7868FB5649F9}" type="datetimeFigureOut">
              <a:rPr lang="en-CN" smtClean="0"/>
              <a:t>2023/3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5E74F3-C131-96C7-DE3B-29E2E5A4FD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84D79E5-517E-419B-8131-3BFED903AD7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60F0BC-FDEF-EE40-B6E6-4EB9775D8647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8188960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FB218A9-1F73-D6C8-4C79-98961BFD0FD4}"/>
              </a:ext>
            </a:extLst>
          </p:cNvPr>
          <p:cNvSpPr txBox="1"/>
          <p:nvPr/>
        </p:nvSpPr>
        <p:spPr>
          <a:xfrm>
            <a:off x="0" y="-1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</a:p>
        </p:txBody>
      </p:sp>
      <p:pic>
        <p:nvPicPr>
          <p:cNvPr id="2" name="Picture 1" descr="Chart&#10;&#10;Description automatically generated">
            <a:extLst>
              <a:ext uri="{FF2B5EF4-FFF2-40B4-BE49-F238E27FC236}">
                <a16:creationId xmlns:a16="http://schemas.microsoft.com/office/drawing/2014/main" id="{3D2665F6-B5C5-1961-B43C-5B80C44035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330" y="369330"/>
            <a:ext cx="10404992" cy="64886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555789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, histogram&#10;&#10;Description automatically generated">
            <a:extLst>
              <a:ext uri="{FF2B5EF4-FFF2-40B4-BE49-F238E27FC236}">
                <a16:creationId xmlns:a16="http://schemas.microsoft.com/office/drawing/2014/main" id="{9C6A7CC7-68B2-1521-1212-DC0A60B522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1709" y="970195"/>
            <a:ext cx="6688581" cy="5701649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828A8CD-6E7A-BB22-2CF5-6447D932BF0C}"/>
              </a:ext>
            </a:extLst>
          </p:cNvPr>
          <p:cNvSpPr txBox="1"/>
          <p:nvPr/>
        </p:nvSpPr>
        <p:spPr>
          <a:xfrm>
            <a:off x="0" y="0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</a:p>
        </p:txBody>
      </p:sp>
    </p:spTree>
    <p:extLst>
      <p:ext uri="{BB962C8B-B14F-4D97-AF65-F5344CB8AC3E}">
        <p14:creationId xmlns:p14="http://schemas.microsoft.com/office/powerpoint/2010/main" val="163368501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Content Placeholder 8" descr="Chart, sunburst chart&#10;&#10;Description automatically generated">
            <a:extLst>
              <a:ext uri="{FF2B5EF4-FFF2-40B4-BE49-F238E27FC236}">
                <a16:creationId xmlns:a16="http://schemas.microsoft.com/office/drawing/2014/main" id="{59EBEE3B-7B39-CD2A-BDD6-42559F84DC2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3"/>
          <a:stretch>
            <a:fillRect/>
          </a:stretch>
        </p:blipFill>
        <p:spPr>
          <a:xfrm>
            <a:off x="2109243" y="0"/>
            <a:ext cx="8072725" cy="6846406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D23A147-6541-2C4B-2F83-8FEE381CC621}"/>
              </a:ext>
            </a:extLst>
          </p:cNvPr>
          <p:cNvSpPr txBox="1"/>
          <p:nvPr/>
        </p:nvSpPr>
        <p:spPr>
          <a:xfrm>
            <a:off x="0" y="0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AFCAF00-195D-42C7-AF52-E2CE8BA3623E}"/>
              </a:ext>
            </a:extLst>
          </p:cNvPr>
          <p:cNvSpPr txBox="1"/>
          <p:nvPr/>
        </p:nvSpPr>
        <p:spPr>
          <a:xfrm>
            <a:off x="0" y="369332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8549402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8DB60DDD-F21C-BBF6-A199-E46807C16711}"/>
              </a:ext>
            </a:extLst>
          </p:cNvPr>
          <p:cNvSpPr txBox="1"/>
          <p:nvPr/>
        </p:nvSpPr>
        <p:spPr>
          <a:xfrm>
            <a:off x="0" y="0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pic>
        <p:nvPicPr>
          <p:cNvPr id="6" name="Picture 5" descr="Chart, sunburst chart&#10;&#10;Description automatically generated">
            <a:extLst>
              <a:ext uri="{FF2B5EF4-FFF2-40B4-BE49-F238E27FC236}">
                <a16:creationId xmlns:a16="http://schemas.microsoft.com/office/drawing/2014/main" id="{7059C690-35FA-FC62-9FE9-1B6F5CE43B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1481" y="0"/>
            <a:ext cx="806903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33209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hart&#10;&#10;Description automatically generated">
            <a:extLst>
              <a:ext uri="{FF2B5EF4-FFF2-40B4-BE49-F238E27FC236}">
                <a16:creationId xmlns:a16="http://schemas.microsoft.com/office/drawing/2014/main" id="{2A9F7C41-3A16-7575-2A2B-9E426B5CB1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38764" y="309028"/>
            <a:ext cx="9123783" cy="654897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1324F5C-738C-1A46-7E63-79F74C655277}"/>
              </a:ext>
            </a:extLst>
          </p:cNvPr>
          <p:cNvSpPr txBox="1"/>
          <p:nvPr/>
        </p:nvSpPr>
        <p:spPr>
          <a:xfrm>
            <a:off x="0" y="-29639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4.</a:t>
            </a:r>
          </a:p>
        </p:txBody>
      </p:sp>
    </p:spTree>
    <p:extLst>
      <p:ext uri="{BB962C8B-B14F-4D97-AF65-F5344CB8AC3E}">
        <p14:creationId xmlns:p14="http://schemas.microsoft.com/office/powerpoint/2010/main" val="10912179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>
            <a:extLst>
              <a:ext uri="{FF2B5EF4-FFF2-40B4-BE49-F238E27FC236}">
                <a16:creationId xmlns:a16="http://schemas.microsoft.com/office/drawing/2014/main" id="{94B3F2B2-2606-7643-A5ED-AB137EA59666}"/>
              </a:ext>
            </a:extLst>
          </p:cNvPr>
          <p:cNvGrpSpPr/>
          <p:nvPr/>
        </p:nvGrpSpPr>
        <p:grpSpPr>
          <a:xfrm>
            <a:off x="279873" y="892172"/>
            <a:ext cx="11448105" cy="6100170"/>
            <a:chOff x="189338" y="494509"/>
            <a:chExt cx="11448105" cy="6100170"/>
          </a:xfrm>
        </p:grpSpPr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E70767B7-9094-27F1-9D27-223D48E940F3}"/>
                </a:ext>
              </a:extLst>
            </p:cNvPr>
            <p:cNvGrpSpPr/>
            <p:nvPr/>
          </p:nvGrpSpPr>
          <p:grpSpPr>
            <a:xfrm>
              <a:off x="805926" y="3315071"/>
              <a:ext cx="10408081" cy="3279608"/>
              <a:chOff x="803531" y="2990715"/>
              <a:chExt cx="10408081" cy="3279608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53E2E912-6529-BCCD-8C0A-B5F9F64342AC}"/>
                  </a:ext>
                </a:extLst>
              </p:cNvPr>
              <p:cNvGrpSpPr/>
              <p:nvPr/>
            </p:nvGrpSpPr>
            <p:grpSpPr>
              <a:xfrm>
                <a:off x="803531" y="2990715"/>
                <a:ext cx="3344098" cy="2893878"/>
                <a:chOff x="803531" y="2990715"/>
                <a:chExt cx="3344098" cy="2893878"/>
              </a:xfrm>
            </p:grpSpPr>
            <p:sp>
              <p:nvSpPr>
                <p:cNvPr id="62" name="Rectangle 61">
                  <a:extLst>
                    <a:ext uri="{FF2B5EF4-FFF2-40B4-BE49-F238E27FC236}">
                      <a16:creationId xmlns:a16="http://schemas.microsoft.com/office/drawing/2014/main" id="{725098D4-E749-F50B-8D1C-855056A124BB}"/>
                    </a:ext>
                  </a:extLst>
                </p:cNvPr>
                <p:cNvSpPr/>
                <p:nvPr/>
              </p:nvSpPr>
              <p:spPr>
                <a:xfrm>
                  <a:off x="821637" y="2990715"/>
                  <a:ext cx="3325992" cy="2893875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</a:t>
                  </a:r>
                </a:p>
              </p:txBody>
            </p:sp>
            <p:pic>
              <p:nvPicPr>
                <p:cNvPr id="63" name="Picture 62">
                  <a:extLst>
                    <a:ext uri="{FF2B5EF4-FFF2-40B4-BE49-F238E27FC236}">
                      <a16:creationId xmlns:a16="http://schemas.microsoft.com/office/drawing/2014/main" id="{AAF69E02-1872-732B-4DD1-B55FEF25F7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03531" y="3057659"/>
                  <a:ext cx="3325992" cy="2826934"/>
                </a:xfrm>
                <a:prstGeom prst="rect">
                  <a:avLst/>
                </a:prstGeom>
              </p:spPr>
            </p:pic>
          </p:grpSp>
          <p:sp>
            <p:nvSpPr>
              <p:cNvPr id="58" name="Rectangle 57">
                <a:extLst>
                  <a:ext uri="{FF2B5EF4-FFF2-40B4-BE49-F238E27FC236}">
                    <a16:creationId xmlns:a16="http://schemas.microsoft.com/office/drawing/2014/main" id="{41B5B77C-9A50-0958-0CC0-360CC43E340B}"/>
                  </a:ext>
                </a:extLst>
              </p:cNvPr>
              <p:cNvSpPr/>
              <p:nvPr/>
            </p:nvSpPr>
            <p:spPr>
              <a:xfrm>
                <a:off x="4585617" y="2990715"/>
                <a:ext cx="2828880" cy="2908224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#Standards on variant location:</a:t>
                </a: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whole genome/ within a specifc range</a:t>
                </a:r>
              </a:p>
              <a:p>
                <a:endParaRPr lang="en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#Standards on variant impact type:</a:t>
                </a: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missense mutation/</a:t>
                </a:r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nonsense</a:t>
                </a:r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 mutation</a:t>
                </a:r>
              </a:p>
              <a:p>
                <a:endParaRPr lang="en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#Standards on specific variant impact:</a:t>
                </a: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Glu to Arg/ at least 10% of protein sequence truncated</a:t>
                </a:r>
              </a:p>
              <a:p>
                <a:endParaRPr lang="en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…</a:t>
                </a:r>
              </a:p>
            </p:txBody>
          </p:sp>
          <p:grpSp>
            <p:nvGrpSpPr>
              <p:cNvPr id="59" name="Group 58">
                <a:extLst>
                  <a:ext uri="{FF2B5EF4-FFF2-40B4-BE49-F238E27FC236}">
                    <a16:creationId xmlns:a16="http://schemas.microsoft.com/office/drawing/2014/main" id="{2C138E96-512A-D077-D471-26E3CAE5FC6A}"/>
                  </a:ext>
                </a:extLst>
              </p:cNvPr>
              <p:cNvGrpSpPr/>
              <p:nvPr/>
            </p:nvGrpSpPr>
            <p:grpSpPr>
              <a:xfrm>
                <a:off x="8068704" y="2990715"/>
                <a:ext cx="3142908" cy="3279608"/>
                <a:chOff x="8068704" y="2990715"/>
                <a:chExt cx="3142908" cy="3279608"/>
              </a:xfrm>
            </p:grpSpPr>
            <p:sp>
              <p:nvSpPr>
                <p:cNvPr id="60" name="Rectangle 59">
                  <a:extLst>
                    <a:ext uri="{FF2B5EF4-FFF2-40B4-BE49-F238E27FC236}">
                      <a16:creationId xmlns:a16="http://schemas.microsoft.com/office/drawing/2014/main" id="{EF7688F0-C9A0-A0C9-48F8-40EC9F919CCE}"/>
                    </a:ext>
                  </a:extLst>
                </p:cNvPr>
                <p:cNvSpPr/>
                <p:nvPr/>
              </p:nvSpPr>
              <p:spPr>
                <a:xfrm>
                  <a:off x="8068704" y="2990715"/>
                  <a:ext cx="2686814" cy="2908221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#Sample ID     Classification label   Sample 1                  Label A</a:t>
                  </a: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mple 2                  Label B</a:t>
                  </a: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mple 3                  Label C</a:t>
                  </a: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ample 4                  Label B</a:t>
                  </a: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                            …</a:t>
                  </a: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61" name="Rectangle 60">
                  <a:extLst>
                    <a:ext uri="{FF2B5EF4-FFF2-40B4-BE49-F238E27FC236}">
                      <a16:creationId xmlns:a16="http://schemas.microsoft.com/office/drawing/2014/main" id="{B467832D-56FA-33E1-F615-A6BF6F5C97EE}"/>
                    </a:ext>
                  </a:extLst>
                </p:cNvPr>
                <p:cNvSpPr/>
                <p:nvPr/>
              </p:nvSpPr>
              <p:spPr>
                <a:xfrm>
                  <a:off x="8524798" y="4184724"/>
                  <a:ext cx="2686814" cy="2085599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riant frequency &gt; 0.9 in sample set A while variant frequency &lt; 0.1 in sample set B</a:t>
                  </a:r>
                </a:p>
                <a:p>
                  <a:pPr algn="ctr"/>
                  <a:endParaRPr lang="en-CN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…</a:t>
                  </a:r>
                </a:p>
              </p:txBody>
            </p:sp>
          </p:grp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28CC4726-D36B-88B6-2678-B6F81E3B2806}"/>
                </a:ext>
              </a:extLst>
            </p:cNvPr>
            <p:cNvGrpSpPr/>
            <p:nvPr/>
          </p:nvGrpSpPr>
          <p:grpSpPr>
            <a:xfrm>
              <a:off x="189338" y="494509"/>
              <a:ext cx="11448105" cy="2190544"/>
              <a:chOff x="217284" y="2018719"/>
              <a:chExt cx="11448105" cy="2190544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869B6737-EFC9-C771-6D33-3C3A73281FE5}"/>
                  </a:ext>
                </a:extLst>
              </p:cNvPr>
              <p:cNvSpPr/>
              <p:nvPr/>
            </p:nvSpPr>
            <p:spPr>
              <a:xfrm>
                <a:off x="217284" y="2018719"/>
                <a:ext cx="2002198" cy="7511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 annotated VCF file</a:t>
                </a:r>
              </a:p>
            </p:txBody>
          </p:sp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9CBA50BF-23A5-1850-4463-6A718B8A0A6E}"/>
                  </a:ext>
                </a:extLst>
              </p:cNvPr>
              <p:cNvSpPr/>
              <p:nvPr/>
            </p:nvSpPr>
            <p:spPr>
              <a:xfrm>
                <a:off x="3357876" y="2018719"/>
                <a:ext cx="2002198" cy="7511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iltered VCF file</a:t>
                </a:r>
              </a:p>
            </p:txBody>
          </p:sp>
          <p:sp>
            <p:nvSpPr>
              <p:cNvPr id="43" name="Rectangle 42">
                <a:extLst>
                  <a:ext uri="{FF2B5EF4-FFF2-40B4-BE49-F238E27FC236}">
                    <a16:creationId xmlns:a16="http://schemas.microsoft.com/office/drawing/2014/main" id="{461F21E8-2C5E-AB76-348E-1C0228A59D92}"/>
                  </a:ext>
                </a:extLst>
              </p:cNvPr>
              <p:cNvSpPr/>
              <p:nvPr/>
            </p:nvSpPr>
            <p:spPr>
              <a:xfrm>
                <a:off x="6510534" y="2028650"/>
                <a:ext cx="2002198" cy="7511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F</a:t>
                </a:r>
                <a:r>
                  <a:rPr lang="en-US" sz="12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</a:t>
                </a:r>
                <a:r>
                  <a:rPr lang="en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ltered VCF file on variant sites of interest</a:t>
                </a:r>
              </a:p>
            </p:txBody>
          </p:sp>
          <p:grpSp>
            <p:nvGrpSpPr>
              <p:cNvPr id="44" name="Group 43">
                <a:extLst>
                  <a:ext uri="{FF2B5EF4-FFF2-40B4-BE49-F238E27FC236}">
                    <a16:creationId xmlns:a16="http://schemas.microsoft.com/office/drawing/2014/main" id="{42DA7334-6A1C-874A-31B2-0C7CBFE71278}"/>
                  </a:ext>
                </a:extLst>
              </p:cNvPr>
              <p:cNvGrpSpPr/>
              <p:nvPr/>
            </p:nvGrpSpPr>
            <p:grpSpPr>
              <a:xfrm>
                <a:off x="1787580" y="2394041"/>
                <a:ext cx="2002197" cy="1786061"/>
                <a:chOff x="1787580" y="2394041"/>
                <a:chExt cx="2002197" cy="1786061"/>
              </a:xfrm>
            </p:grpSpPr>
            <p:sp>
              <p:nvSpPr>
                <p:cNvPr id="54" name="Rectangle 53">
                  <a:extLst>
                    <a:ext uri="{FF2B5EF4-FFF2-40B4-BE49-F238E27FC236}">
                      <a16:creationId xmlns:a16="http://schemas.microsoft.com/office/drawing/2014/main" id="{5009EF25-8AA3-0567-FB55-F73C07282717}"/>
                    </a:ext>
                  </a:extLst>
                </p:cNvPr>
                <p:cNvSpPr/>
                <p:nvPr/>
              </p:nvSpPr>
              <p:spPr>
                <a:xfrm>
                  <a:off x="1787580" y="3429000"/>
                  <a:ext cx="2002197" cy="7511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pth-based quality standard for qualified variants</a:t>
                  </a:r>
                </a:p>
              </p:txBody>
            </p:sp>
            <p:cxnSp>
              <p:nvCxnSpPr>
                <p:cNvPr id="55" name="Straight Arrow Connector 54">
                  <a:extLst>
                    <a:ext uri="{FF2B5EF4-FFF2-40B4-BE49-F238E27FC236}">
                      <a16:creationId xmlns:a16="http://schemas.microsoft.com/office/drawing/2014/main" id="{F817936C-A91A-1143-EA24-28E8E0629E74}"/>
                    </a:ext>
                  </a:extLst>
                </p:cNvPr>
                <p:cNvCxnSpPr>
                  <a:cxnSpLocks/>
                  <a:stCxn id="41" idx="3"/>
                </p:cNvCxnSpPr>
                <p:nvPr/>
              </p:nvCxnSpPr>
              <p:spPr>
                <a:xfrm>
                  <a:off x="2219482" y="2394270"/>
                  <a:ext cx="1138394" cy="0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Straight Arrow Connector 55">
                  <a:extLst>
                    <a:ext uri="{FF2B5EF4-FFF2-40B4-BE49-F238E27FC236}">
                      <a16:creationId xmlns:a16="http://schemas.microsoft.com/office/drawing/2014/main" id="{784870F8-3C18-DF52-F93E-6A739087A3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2788680" y="2394041"/>
                  <a:ext cx="0" cy="103495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5" name="Straight Arrow Connector 44">
                <a:extLst>
                  <a:ext uri="{FF2B5EF4-FFF2-40B4-BE49-F238E27FC236}">
                    <a16:creationId xmlns:a16="http://schemas.microsoft.com/office/drawing/2014/main" id="{9C350C5C-65B2-E160-61F6-9B94319F4B4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360074" y="2423202"/>
                <a:ext cx="1138394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6" name="Straight Arrow Connector 45">
                <a:extLst>
                  <a:ext uri="{FF2B5EF4-FFF2-40B4-BE49-F238E27FC236}">
                    <a16:creationId xmlns:a16="http://schemas.microsoft.com/office/drawing/2014/main" id="{9BF72266-D517-17D8-76ED-4D8015EA865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524798" y="2413701"/>
                <a:ext cx="1138394" cy="0"/>
              </a:xfrm>
              <a:prstGeom prst="straightConnector1">
                <a:avLst/>
              </a:prstGeom>
              <a:ln>
                <a:tailEnd type="triangle"/>
              </a:ln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47" name="Group 46">
                <a:extLst>
                  <a:ext uri="{FF2B5EF4-FFF2-40B4-BE49-F238E27FC236}">
                    <a16:creationId xmlns:a16="http://schemas.microsoft.com/office/drawing/2014/main" id="{51FAFAF2-62E4-6AE8-DF57-8E815B6E1A6B}"/>
                  </a:ext>
                </a:extLst>
              </p:cNvPr>
              <p:cNvGrpSpPr/>
              <p:nvPr/>
            </p:nvGrpSpPr>
            <p:grpSpPr>
              <a:xfrm>
                <a:off x="8121530" y="2423202"/>
                <a:ext cx="2002198" cy="1786042"/>
                <a:chOff x="8121530" y="2423202"/>
                <a:chExt cx="2002198" cy="1786042"/>
              </a:xfrm>
            </p:grpSpPr>
            <p:sp>
              <p:nvSpPr>
                <p:cNvPr id="52" name="Rectangle 51">
                  <a:extLst>
                    <a:ext uri="{FF2B5EF4-FFF2-40B4-BE49-F238E27FC236}">
                      <a16:creationId xmlns:a16="http://schemas.microsoft.com/office/drawing/2014/main" id="{96921413-33BE-97A3-F0AE-19B00955668D}"/>
                    </a:ext>
                  </a:extLst>
                </p:cNvPr>
                <p:cNvSpPr/>
                <p:nvPr/>
              </p:nvSpPr>
              <p:spPr>
                <a:xfrm>
                  <a:off x="8121530" y="3458142"/>
                  <a:ext cx="2002198" cy="7511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 sample label file and frequency-based searching criteria for target variants</a:t>
                  </a:r>
                </a:p>
              </p:txBody>
            </p:sp>
            <p:cxnSp>
              <p:nvCxnSpPr>
                <p:cNvPr id="53" name="Straight Arrow Connector 52">
                  <a:extLst>
                    <a:ext uri="{FF2B5EF4-FFF2-40B4-BE49-F238E27FC236}">
                      <a16:creationId xmlns:a16="http://schemas.microsoft.com/office/drawing/2014/main" id="{28F85436-1879-0A84-12DB-83B4486198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9122629" y="2423202"/>
                  <a:ext cx="0" cy="103495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A7BD5483-D4E4-9F3A-4C4C-8BBE6F388874}"/>
                  </a:ext>
                </a:extLst>
              </p:cNvPr>
              <p:cNvSpPr/>
              <p:nvPr/>
            </p:nvSpPr>
            <p:spPr>
              <a:xfrm>
                <a:off x="9663191" y="2047651"/>
                <a:ext cx="2002198" cy="751102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5"/>
              </a:lnRef>
              <a:fillRef idx="1">
                <a:schemeClr val="lt1"/>
              </a:fillRef>
              <a:effectRef idx="0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Output list of variants qualifying all inclusion criteria</a:t>
                </a:r>
                <a:endParaRPr lang="en-CN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9" name="Group 48">
                <a:extLst>
                  <a:ext uri="{FF2B5EF4-FFF2-40B4-BE49-F238E27FC236}">
                    <a16:creationId xmlns:a16="http://schemas.microsoft.com/office/drawing/2014/main" id="{CE756439-3FF3-B33D-969A-FCAF3419F7A0}"/>
                  </a:ext>
                </a:extLst>
              </p:cNvPr>
              <p:cNvGrpSpPr/>
              <p:nvPr/>
            </p:nvGrpSpPr>
            <p:grpSpPr>
              <a:xfrm>
                <a:off x="4928172" y="2423202"/>
                <a:ext cx="2002198" cy="1786061"/>
                <a:chOff x="4928172" y="2423202"/>
                <a:chExt cx="2002198" cy="1786061"/>
              </a:xfrm>
            </p:grpSpPr>
            <p:sp>
              <p:nvSpPr>
                <p:cNvPr id="50" name="Rectangle 49">
                  <a:extLst>
                    <a:ext uri="{FF2B5EF4-FFF2-40B4-BE49-F238E27FC236}">
                      <a16:creationId xmlns:a16="http://schemas.microsoft.com/office/drawing/2014/main" id="{3EE0C223-5B3F-2B35-DEF4-31B06CB0B7BC}"/>
                    </a:ext>
                  </a:extLst>
                </p:cNvPr>
                <p:cNvSpPr/>
                <p:nvPr/>
              </p:nvSpPr>
              <p:spPr>
                <a:xfrm>
                  <a:off x="4928172" y="3458161"/>
                  <a:ext cx="2002198" cy="751102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5"/>
                </a:lnRef>
                <a:fillRef idx="1">
                  <a:schemeClr val="lt1"/>
                </a:fillRef>
                <a:effectRef idx="0">
                  <a:schemeClr val="accent5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nnotation based inclusion criteria for variants of interest </a:t>
                  </a:r>
                </a:p>
              </p:txBody>
            </p:sp>
            <p:cxnSp>
              <p:nvCxnSpPr>
                <p:cNvPr id="51" name="Straight Arrow Connector 50">
                  <a:extLst>
                    <a:ext uri="{FF2B5EF4-FFF2-40B4-BE49-F238E27FC236}">
                      <a16:creationId xmlns:a16="http://schemas.microsoft.com/office/drawing/2014/main" id="{10A4356E-4C25-DB0A-7B26-F84D73665E4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5929271" y="2423202"/>
                  <a:ext cx="0" cy="1034959"/>
                </a:xfrm>
                <a:prstGeom prst="straightConnector1">
                  <a:avLst/>
                </a:prstGeom>
                <a:ln>
                  <a:tailEnd type="triangle"/>
                </a:ln>
              </p:spPr>
              <p:style>
                <a:lnRef idx="2">
                  <a:schemeClr val="dk1"/>
                </a:lnRef>
                <a:fillRef idx="0">
                  <a:schemeClr val="dk1"/>
                </a:fillRef>
                <a:effectRef idx="1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37" name="Group 36">
              <a:extLst>
                <a:ext uri="{FF2B5EF4-FFF2-40B4-BE49-F238E27FC236}">
                  <a16:creationId xmlns:a16="http://schemas.microsoft.com/office/drawing/2014/main" id="{79CB9BD2-6887-D0E3-0EA6-07AE0240AF61}"/>
                </a:ext>
              </a:extLst>
            </p:cNvPr>
            <p:cNvGrpSpPr/>
            <p:nvPr/>
          </p:nvGrpSpPr>
          <p:grpSpPr>
            <a:xfrm>
              <a:off x="2670485" y="2767156"/>
              <a:ext cx="6514445" cy="465802"/>
              <a:chOff x="2670485" y="2767156"/>
              <a:chExt cx="6514445" cy="465802"/>
            </a:xfrm>
          </p:grpSpPr>
          <p:sp>
            <p:nvSpPr>
              <p:cNvPr id="38" name="Up-Down Arrow 37">
                <a:extLst>
                  <a:ext uri="{FF2B5EF4-FFF2-40B4-BE49-F238E27FC236}">
                    <a16:creationId xmlns:a16="http://schemas.microsoft.com/office/drawing/2014/main" id="{5C1B9431-8F8A-0A83-67D1-771C31F72C56}"/>
                  </a:ext>
                </a:extLst>
              </p:cNvPr>
              <p:cNvSpPr/>
              <p:nvPr/>
            </p:nvSpPr>
            <p:spPr>
              <a:xfrm>
                <a:off x="2670485" y="2767156"/>
                <a:ext cx="180494" cy="465792"/>
              </a:xfrm>
              <a:prstGeom prst="upDownArrow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CN" sz="1200"/>
              </a:p>
            </p:txBody>
          </p:sp>
          <p:sp>
            <p:nvSpPr>
              <p:cNvPr id="39" name="Up-Down Arrow 38">
                <a:extLst>
                  <a:ext uri="{FF2B5EF4-FFF2-40B4-BE49-F238E27FC236}">
                    <a16:creationId xmlns:a16="http://schemas.microsoft.com/office/drawing/2014/main" id="{62C77F20-3A77-C79F-AC16-EEB84B438665}"/>
                  </a:ext>
                </a:extLst>
              </p:cNvPr>
              <p:cNvSpPr/>
              <p:nvPr/>
            </p:nvSpPr>
            <p:spPr>
              <a:xfrm>
                <a:off x="5811078" y="2767166"/>
                <a:ext cx="180494" cy="465792"/>
              </a:xfrm>
              <a:prstGeom prst="upDownArrow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CN" sz="1200"/>
              </a:p>
            </p:txBody>
          </p:sp>
          <p:sp>
            <p:nvSpPr>
              <p:cNvPr id="40" name="Up-Down Arrow 39">
                <a:extLst>
                  <a:ext uri="{FF2B5EF4-FFF2-40B4-BE49-F238E27FC236}">
                    <a16:creationId xmlns:a16="http://schemas.microsoft.com/office/drawing/2014/main" id="{7DD98A75-B5C4-B4E8-0201-0EBC8E0F367B}"/>
                  </a:ext>
                </a:extLst>
              </p:cNvPr>
              <p:cNvSpPr/>
              <p:nvPr/>
            </p:nvSpPr>
            <p:spPr>
              <a:xfrm>
                <a:off x="9004436" y="2767156"/>
                <a:ext cx="180494" cy="465792"/>
              </a:xfrm>
              <a:prstGeom prst="upDownArrow">
                <a:avLst/>
              </a:prstGeom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CN" sz="1200"/>
              </a:p>
            </p:txBody>
          </p:sp>
        </p:grpSp>
      </p:grpSp>
      <p:sp>
        <p:nvSpPr>
          <p:cNvPr id="65" name="TextBox 64">
            <a:extLst>
              <a:ext uri="{FF2B5EF4-FFF2-40B4-BE49-F238E27FC236}">
                <a16:creationId xmlns:a16="http://schemas.microsoft.com/office/drawing/2014/main" id="{3C47052D-24B7-0AE5-9238-0D902F35A000}"/>
              </a:ext>
            </a:extLst>
          </p:cNvPr>
          <p:cNvSpPr txBox="1"/>
          <p:nvPr/>
        </p:nvSpPr>
        <p:spPr>
          <a:xfrm>
            <a:off x="0" y="-33665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5.</a:t>
            </a:r>
          </a:p>
        </p:txBody>
      </p:sp>
    </p:spTree>
    <p:extLst>
      <p:ext uri="{BB962C8B-B14F-4D97-AF65-F5344CB8AC3E}">
        <p14:creationId xmlns:p14="http://schemas.microsoft.com/office/powerpoint/2010/main" val="6706966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2EB1A37-8A35-E236-6D19-7396BEAF59A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771" y="1458201"/>
            <a:ext cx="5392966" cy="417479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7590E18-E58C-CB56-488F-CE48AC5333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58503" y="1458201"/>
            <a:ext cx="5392966" cy="417479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FC520BF-BE3D-E3E3-0E9C-9A3304ACEAEB}"/>
              </a:ext>
            </a:extLst>
          </p:cNvPr>
          <p:cNvSpPr txBox="1"/>
          <p:nvPr/>
        </p:nvSpPr>
        <p:spPr>
          <a:xfrm>
            <a:off x="253393" y="1088869"/>
            <a:ext cx="3433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400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9667B22-32BE-FB08-5CD8-F622AA9ACA9D}"/>
              </a:ext>
            </a:extLst>
          </p:cNvPr>
          <p:cNvSpPr txBox="1"/>
          <p:nvPr/>
        </p:nvSpPr>
        <p:spPr>
          <a:xfrm>
            <a:off x="6075218" y="1088869"/>
            <a:ext cx="3529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N" sz="1400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759A0E8-1BFD-8EFC-15CC-ACD76712437B}"/>
              </a:ext>
            </a:extLst>
          </p:cNvPr>
          <p:cNvSpPr txBox="1"/>
          <p:nvPr/>
        </p:nvSpPr>
        <p:spPr>
          <a:xfrm>
            <a:off x="0" y="0"/>
            <a:ext cx="10482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N" dirty="0">
                <a:latin typeface="Arial" panose="020B0604020202020204" pitchFamily="34" charset="0"/>
                <a:cs typeface="Arial" panose="020B0604020202020204" pitchFamily="34" charset="0"/>
              </a:rPr>
              <a:t>Figure S6.</a:t>
            </a:r>
          </a:p>
        </p:txBody>
      </p:sp>
    </p:spTree>
    <p:extLst>
      <p:ext uri="{BB962C8B-B14F-4D97-AF65-F5344CB8AC3E}">
        <p14:creationId xmlns:p14="http://schemas.microsoft.com/office/powerpoint/2010/main" val="1749511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 2013 - 2022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80</TotalTime>
  <Words>163</Words>
  <Application>Microsoft Macintosh PowerPoint</Application>
  <PresentationFormat>Widescreen</PresentationFormat>
  <Paragraphs>45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 2013 - 2022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icheng Li</dc:creator>
  <cp:lastModifiedBy>Zicheng Li</cp:lastModifiedBy>
  <cp:revision>4</cp:revision>
  <dcterms:created xsi:type="dcterms:W3CDTF">2023-02-08T19:44:49Z</dcterms:created>
  <dcterms:modified xsi:type="dcterms:W3CDTF">2023-03-24T19:21:43Z</dcterms:modified>
</cp:coreProperties>
</file>